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FF4BC50-93DF-4877-A10A-00D568AD6725}" v="1" dt="2025-10-08T11:26:44.6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0" autoAdjust="0"/>
    <p:restoredTop sz="94660"/>
  </p:normalViewPr>
  <p:slideViewPr>
    <p:cSldViewPr snapToGrid="0">
      <p:cViewPr varScale="1">
        <p:scale>
          <a:sx n="76" d="100"/>
          <a:sy n="76" d="100"/>
        </p:scale>
        <p:origin x="643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8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Risk factors for loss </a:t>
            </a:r>
            <a:r>
              <a:rPr lang="en-GB" sz="2800" b="1">
                <a:solidFill>
                  <a:schemeClr val="bg1"/>
                </a:solidFill>
              </a:rPr>
              <a:t>of Varicella </a:t>
            </a:r>
            <a:r>
              <a:rPr lang="en-GB" sz="2800" b="1" dirty="0">
                <a:solidFill>
                  <a:schemeClr val="bg1"/>
                </a:solidFill>
              </a:rPr>
              <a:t>immunity after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kidney transplanta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Assess the influencing factors that can contribute to the loss of VZV immunity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izzo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Pediatric kidney transplant recipients are more likely to lose VZV IgG in those who required 3 or more doses of VZV vaccine to seroconvert, or received VZV vaccine &lt;1 year before transplant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4DE4733-C48F-A381-777D-B98EEB984709}"/>
              </a:ext>
            </a:extLst>
          </p:cNvPr>
          <p:cNvGrpSpPr/>
          <p:nvPr/>
        </p:nvGrpSpPr>
        <p:grpSpPr>
          <a:xfrm>
            <a:off x="666983" y="3117198"/>
            <a:ext cx="957149" cy="1386935"/>
            <a:chOff x="666983" y="2991061"/>
            <a:chExt cx="957149" cy="1386935"/>
          </a:xfrm>
        </p:grpSpPr>
        <p:sp>
          <p:nvSpPr>
            <p:cNvPr id="3" name="Freeform: Shape 46">
              <a:extLst>
                <a:ext uri="{FF2B5EF4-FFF2-40B4-BE49-F238E27FC236}">
                  <a16:creationId xmlns:a16="http://schemas.microsoft.com/office/drawing/2014/main" id="{A1EC860F-071D-F59F-6467-5CE8DF3AF9BC}"/>
                </a:ext>
              </a:extLst>
            </p:cNvPr>
            <p:cNvSpPr/>
            <p:nvPr/>
          </p:nvSpPr>
          <p:spPr>
            <a:xfrm>
              <a:off x="666983" y="301394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" name="Freeform: Shape 46">
              <a:extLst>
                <a:ext uri="{FF2B5EF4-FFF2-40B4-BE49-F238E27FC236}">
                  <a16:creationId xmlns:a16="http://schemas.microsoft.com/office/drawing/2014/main" id="{BE959381-429F-7B70-B202-DE6788E4E614}"/>
                </a:ext>
              </a:extLst>
            </p:cNvPr>
            <p:cNvSpPr/>
            <p:nvPr/>
          </p:nvSpPr>
          <p:spPr>
            <a:xfrm>
              <a:off x="715368" y="3328098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9E1A8522-49B7-4C58-15FF-257A2F8CCB1F}"/>
                </a:ext>
              </a:extLst>
            </p:cNvPr>
            <p:cNvSpPr/>
            <p:nvPr/>
          </p:nvSpPr>
          <p:spPr>
            <a:xfrm>
              <a:off x="1110848" y="299106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A8D051E1-C5CD-CDE5-120A-F16279BE88E4}"/>
                </a:ext>
              </a:extLst>
            </p:cNvPr>
            <p:cNvSpPr/>
            <p:nvPr/>
          </p:nvSpPr>
          <p:spPr>
            <a:xfrm>
              <a:off x="1020395" y="3328098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7182C6AD-FBED-13F3-112A-A0F974C29556}"/>
              </a:ext>
            </a:extLst>
          </p:cNvPr>
          <p:cNvSpPr txBox="1"/>
          <p:nvPr/>
        </p:nvSpPr>
        <p:spPr>
          <a:xfrm>
            <a:off x="169557" y="4659926"/>
            <a:ext cx="212469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Retrospective single center study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B7157D8-E3C3-4B35-2548-5107DC8D7069}"/>
              </a:ext>
            </a:extLst>
          </p:cNvPr>
          <p:cNvSpPr txBox="1"/>
          <p:nvPr/>
        </p:nvSpPr>
        <p:spPr>
          <a:xfrm>
            <a:off x="169557" y="2253519"/>
            <a:ext cx="233190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45 pediatric kidney transplant recipients 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89092CC-1E85-6CA9-CC35-AC17F2761DD9}"/>
              </a:ext>
            </a:extLst>
          </p:cNvPr>
          <p:cNvGrpSpPr/>
          <p:nvPr/>
        </p:nvGrpSpPr>
        <p:grpSpPr>
          <a:xfrm>
            <a:off x="1835736" y="2681474"/>
            <a:ext cx="5844121" cy="2290660"/>
            <a:chOff x="1835736" y="2819065"/>
            <a:chExt cx="5844121" cy="2290660"/>
          </a:xfrm>
        </p:grpSpPr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FF1C9DFB-10E1-0E6C-AB02-7D8FD896C9A2}"/>
                </a:ext>
              </a:extLst>
            </p:cNvPr>
            <p:cNvCxnSpPr/>
            <p:nvPr/>
          </p:nvCxnSpPr>
          <p:spPr>
            <a:xfrm flipV="1">
              <a:off x="4452831" y="3276654"/>
              <a:ext cx="628373" cy="468037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006B07CA-1781-E4F3-7F85-4005BEFA2A93}"/>
                </a:ext>
              </a:extLst>
            </p:cNvPr>
            <p:cNvCxnSpPr/>
            <p:nvPr/>
          </p:nvCxnSpPr>
          <p:spPr>
            <a:xfrm>
              <a:off x="4437646" y="3744691"/>
              <a:ext cx="715833" cy="0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2ED18511-954E-9BE4-88BE-3CC46FF06629}"/>
                </a:ext>
              </a:extLst>
            </p:cNvPr>
            <p:cNvCxnSpPr/>
            <p:nvPr/>
          </p:nvCxnSpPr>
          <p:spPr>
            <a:xfrm>
              <a:off x="4452831" y="3744691"/>
              <a:ext cx="613837" cy="461154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AEB421F-0A50-49CD-7602-71FEA260CA67}"/>
                </a:ext>
              </a:extLst>
            </p:cNvPr>
            <p:cNvSpPr/>
            <p:nvPr/>
          </p:nvSpPr>
          <p:spPr>
            <a:xfrm>
              <a:off x="5299073" y="3387687"/>
              <a:ext cx="2380784" cy="593344"/>
            </a:xfrm>
            <a:prstGeom prst="rect">
              <a:avLst/>
            </a:prstGeom>
            <a:solidFill>
              <a:srgbClr val="296DC0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Number of VZV vaccines received</a:t>
              </a: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9659888C-586E-2BC5-9E42-298DD55C05E3}"/>
                </a:ext>
              </a:extLst>
            </p:cNvPr>
            <p:cNvCxnSpPr/>
            <p:nvPr/>
          </p:nvCxnSpPr>
          <p:spPr>
            <a:xfrm>
              <a:off x="1835736" y="3744691"/>
              <a:ext cx="715833" cy="0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133C48C0-0129-7735-F595-1079331EA797}"/>
                </a:ext>
              </a:extLst>
            </p:cNvPr>
            <p:cNvSpPr/>
            <p:nvPr/>
          </p:nvSpPr>
          <p:spPr>
            <a:xfrm>
              <a:off x="2702333" y="3353518"/>
              <a:ext cx="1735313" cy="845702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Risk factors for loss of VZV IgG post-transplant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648C652A-BC84-0408-049F-E872B075A65A}"/>
                </a:ext>
              </a:extLst>
            </p:cNvPr>
            <p:cNvSpPr/>
            <p:nvPr/>
          </p:nvSpPr>
          <p:spPr>
            <a:xfrm>
              <a:off x="5299073" y="4089415"/>
              <a:ext cx="2380783" cy="1020310"/>
            </a:xfrm>
            <a:prstGeom prst="rect">
              <a:avLst/>
            </a:prstGeom>
            <a:solidFill>
              <a:srgbClr val="296DC0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Interval between last dose of VZV vaccine and transplant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0AA4EA1F-5C81-17CC-B0AC-A9DF985F0926}"/>
                </a:ext>
              </a:extLst>
            </p:cNvPr>
            <p:cNvSpPr/>
            <p:nvPr/>
          </p:nvSpPr>
          <p:spPr>
            <a:xfrm>
              <a:off x="5299073" y="2819065"/>
              <a:ext cx="2380783" cy="401925"/>
            </a:xfrm>
            <a:prstGeom prst="rect">
              <a:avLst/>
            </a:prstGeom>
            <a:solidFill>
              <a:srgbClr val="296DC0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Induction agent</a:t>
              </a:r>
            </a:p>
          </p:txBody>
        </p:sp>
      </p:grpSp>
      <p:pic>
        <p:nvPicPr>
          <p:cNvPr id="31" name="Picture 30" descr="A graph of a patient's life after surgery&#10;&#10;AI-generated content may be incorrect.">
            <a:extLst>
              <a:ext uri="{FF2B5EF4-FFF2-40B4-BE49-F238E27FC236}">
                <a16:creationId xmlns:a16="http://schemas.microsoft.com/office/drawing/2014/main" id="{013B499F-EB5F-B0E6-67BA-31370D2EA8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6"/>
          <a:stretch>
            <a:fillRect/>
          </a:stretch>
        </p:blipFill>
        <p:spPr>
          <a:xfrm>
            <a:off x="8097813" y="3161265"/>
            <a:ext cx="3581569" cy="2471918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F96FF59D-00DF-254E-F87A-1B04019BE0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31838" y="1792455"/>
            <a:ext cx="4063531" cy="1143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06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10-08T11:27:13Z</dcterms:modified>
</cp:coreProperties>
</file>